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43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0E03CF3-D497-2957-6404-D35072E9C0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7BA171B9-5A90-835B-2571-C054BB0702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5F2A9F5-C1E7-F947-6A72-D46205D52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5F0C3B37-E12F-7F5A-E4D7-6808519BF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5A78453E-AFBA-AD27-FA19-A632A74A3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54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C6FB0D79-A49A-FFFA-A6DB-6EAF5E733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EA3DF9F3-6D33-CA79-3FE2-A9F8C5C61F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0BCE318-A717-AD88-6202-F3092CF65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7969196-CBAA-6922-5795-9CD85C8B3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F380AB0C-8190-B664-9B7C-E29ACCC01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39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735AE4D9-38BF-2059-D03A-8E358B474F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333AF06-1A5D-8B44-07A7-E2EB8578F2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B0485348-CEB2-6B2F-2539-017A6457F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0A04C78E-4958-86B7-9B5A-7D1EEC922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EC484F2-F3DE-BA77-95FD-F8E2473D3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761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706FE9B-34B8-7F05-FD93-26C2C16AB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B1A175A6-A7B7-E1DA-1812-C02341CDF9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7CDBDD4A-C08E-1DB4-C88E-FB3ECD30E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29DEC78-C9CE-8603-8937-115A5440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E9F030F-2E1B-A07C-4029-0B5A14B88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69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14AF2D0-C1C5-D6F7-3561-2E687DB017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B07C0CB5-C7E9-7143-CC47-1C6253BB1D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6E20741-A474-9914-07B5-562F48CDF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8B0A872-4C1D-849F-AB03-1A666B470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74A95FDB-49BF-214C-8C92-9D174A6DB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507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E06DE7DE-02E3-D16C-AA3B-9C5645EB2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CCF3C18-46ED-0E40-FDEB-6A38C03BBA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8ECDDD57-3C00-CE82-EE05-A777576576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6164987C-E6EC-E89F-C441-A7F46396F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38E85336-76DB-22A1-DD65-66DE452C3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9218BADA-377D-9514-B6B3-91E7D4A67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851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59D84D7-A7A0-543D-9725-5CF30DD9AA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15502054-ADFB-2AF2-6AA1-ED33C40F2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8C44AB08-ED6D-B06C-1D62-C687CB120E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37A10382-FE04-BC3A-B52B-426825A245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564C134C-B1AC-2C77-6D06-E02F6C0632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01158B5C-E4D2-2532-1330-DDF4F757D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0D08C2AB-5067-0FA4-5AA1-7BD63EB9E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547E913A-327B-0425-770D-2D694A842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409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3BBCA80-C3F1-86FD-5AF0-AABCF88BC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91D0F4CA-56A8-843C-47A8-E0315608E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706ABE6B-CAB1-1FCF-B990-DC65FA756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099164B5-0F9A-9FBA-0626-1B540DA5F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243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618DAB4B-9190-1189-3D70-8CE09C9D4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76ABF05A-0AB8-A638-2ECA-EBCC9F5B5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A85D07FD-EDE8-C56B-123D-7E042A05C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23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56063A0-755B-30E8-CAE3-D3E8C8B29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8C3AC3E0-3A82-11D5-D2A5-BEA287F95F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F5EFF740-F267-0DA9-F693-3FF87F1E0A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A56EBBF3-58AA-427D-9C90-55B6A8B73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A135EFDF-2B11-E77C-BCDB-40818195D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A303A9E0-7293-786A-5B81-81C4D2F19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5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84B408D-6010-C73F-62B8-FD704D463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63079319-A14C-BDD9-3189-F23F4A45DA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42F16CA1-39D2-E5D7-F550-3538ED2E55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978EF4FF-3A92-611A-2BEF-1B34B5465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C5F27D4A-B37B-9EF0-731B-5047B8B5C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8D63C45-FA1E-7545-89B4-71907F9C6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755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644DE3F5-E260-B893-E291-FF7DBCCBA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865665B-5F03-9088-D2BD-6D8CE4965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D63A05D3-20A3-E6CC-BB10-07F35718E3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C0D74-B734-4DA1-9FFC-7700E4FA1CCC}" type="datetimeFigureOut">
              <a:rPr lang="en-US" smtClean="0"/>
              <a:t>2/21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9C0741B-36D1-240F-56D1-F5D508A430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8823611-4D1D-DCCA-E810-1AD48A33E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3A118-6AA7-4C32-8AD0-0957A52A4B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160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ikdörtgen 3">
            <a:extLst>
              <a:ext uri="{FF2B5EF4-FFF2-40B4-BE49-F238E27FC236}">
                <a16:creationId xmlns:a16="http://schemas.microsoft.com/office/drawing/2014/main" id="{DAD6809D-C477-9CA2-E53B-AF301723973C}"/>
              </a:ext>
            </a:extLst>
          </p:cNvPr>
          <p:cNvSpPr/>
          <p:nvPr/>
        </p:nvSpPr>
        <p:spPr>
          <a:xfrm>
            <a:off x="1204686" y="957943"/>
            <a:ext cx="6574971" cy="53122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Metin kutusu 4">
            <a:extLst>
              <a:ext uri="{FF2B5EF4-FFF2-40B4-BE49-F238E27FC236}">
                <a16:creationId xmlns:a16="http://schemas.microsoft.com/office/drawing/2014/main" id="{20982B26-3D10-4B4F-A821-F40E20F6410D}"/>
              </a:ext>
            </a:extLst>
          </p:cNvPr>
          <p:cNvSpPr txBox="1"/>
          <p:nvPr/>
        </p:nvSpPr>
        <p:spPr>
          <a:xfrm>
            <a:off x="4064001" y="1103085"/>
            <a:ext cx="3556000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spcBef>
                <a:spcPts val="1200"/>
              </a:spcBef>
            </a:pPr>
            <a:r>
              <a:rPr lang="en-US" noProof="0" dirty="0">
                <a:latin typeface="Arial" panose="020B0604020202020204" pitchFamily="34" charset="0"/>
                <a:cs typeface="Arial" panose="020B0604020202020204" pitchFamily="34" charset="0"/>
              </a:rPr>
              <a:t>100 patients foll</a:t>
            </a:r>
            <a:r>
              <a:rPr lang="tr-TR" noProof="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noProof="0" dirty="0">
                <a:latin typeface="Arial" panose="020B0604020202020204" pitchFamily="34" charset="0"/>
                <a:cs typeface="Arial" panose="020B0604020202020204" pitchFamily="34" charset="0"/>
              </a:rPr>
              <a:t>wed with diagnosis of DGS/DTD between January 2000 and May 2019</a:t>
            </a:r>
          </a:p>
        </p:txBody>
      </p:sp>
      <p:sp>
        <p:nvSpPr>
          <p:cNvPr id="6" name="Metin kutusu 5">
            <a:extLst>
              <a:ext uri="{FF2B5EF4-FFF2-40B4-BE49-F238E27FC236}">
                <a16:creationId xmlns:a16="http://schemas.microsoft.com/office/drawing/2014/main" id="{2F73CF71-BD97-1ECB-9ADA-1C7512DA1B3A}"/>
              </a:ext>
            </a:extLst>
          </p:cNvPr>
          <p:cNvSpPr txBox="1"/>
          <p:nvPr/>
        </p:nvSpPr>
        <p:spPr>
          <a:xfrm>
            <a:off x="4937759" y="3614057"/>
            <a:ext cx="2082801" cy="3693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tr-TR" noProof="0" dirty="0">
                <a:latin typeface="Arial" panose="020B0604020202020204" pitchFamily="34" charset="0"/>
                <a:cs typeface="Arial" panose="020B0604020202020204" pitchFamily="34" charset="0"/>
              </a:rPr>
              <a:t>79 patients</a:t>
            </a:r>
            <a:endParaRPr lang="en-US" noProof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Metin kutusu 6">
            <a:extLst>
              <a:ext uri="{FF2B5EF4-FFF2-40B4-BE49-F238E27FC236}">
                <a16:creationId xmlns:a16="http://schemas.microsoft.com/office/drawing/2014/main" id="{B4AD22AB-02FD-1950-1D9C-3F59588D019F}"/>
              </a:ext>
            </a:extLst>
          </p:cNvPr>
          <p:cNvSpPr txBox="1"/>
          <p:nvPr/>
        </p:nvSpPr>
        <p:spPr>
          <a:xfrm>
            <a:off x="1554480" y="2751800"/>
            <a:ext cx="2830287" cy="7848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spcBef>
                <a:spcPts val="1200"/>
              </a:spcBef>
            </a:pPr>
            <a:r>
              <a:rPr lang="en-US" sz="1500" noProof="0" dirty="0">
                <a:latin typeface="Arial" panose="020B0604020202020204" pitchFamily="34" charset="0"/>
                <a:cs typeface="Arial" panose="020B0604020202020204" pitchFamily="34" charset="0"/>
              </a:rPr>
              <a:t>21 patients had missing history, physical examination or immunological evaluation</a:t>
            </a:r>
          </a:p>
        </p:txBody>
      </p:sp>
      <p:sp>
        <p:nvSpPr>
          <p:cNvPr id="8" name="Metin kutusu 7">
            <a:extLst>
              <a:ext uri="{FF2B5EF4-FFF2-40B4-BE49-F238E27FC236}">
                <a16:creationId xmlns:a16="http://schemas.microsoft.com/office/drawing/2014/main" id="{5C140C1C-77AB-D10C-B3BC-974E2E7792AD}"/>
              </a:ext>
            </a:extLst>
          </p:cNvPr>
          <p:cNvSpPr txBox="1"/>
          <p:nvPr/>
        </p:nvSpPr>
        <p:spPr>
          <a:xfrm>
            <a:off x="4937758" y="5507502"/>
            <a:ext cx="2082801" cy="3693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tr-TR" noProof="0" dirty="0">
                <a:latin typeface="Arial" panose="020B0604020202020204" pitchFamily="34" charset="0"/>
                <a:cs typeface="Arial" panose="020B0604020202020204" pitchFamily="34" charset="0"/>
              </a:rPr>
              <a:t>72 patients</a:t>
            </a:r>
            <a:endParaRPr lang="en-US" noProof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Metin kutusu 8">
            <a:extLst>
              <a:ext uri="{FF2B5EF4-FFF2-40B4-BE49-F238E27FC236}">
                <a16:creationId xmlns:a16="http://schemas.microsoft.com/office/drawing/2014/main" id="{F13B5474-86E8-F458-1402-C2C6647861A1}"/>
              </a:ext>
            </a:extLst>
          </p:cNvPr>
          <p:cNvSpPr txBox="1"/>
          <p:nvPr/>
        </p:nvSpPr>
        <p:spPr>
          <a:xfrm>
            <a:off x="1554480" y="4722672"/>
            <a:ext cx="2830287" cy="7848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spcBef>
                <a:spcPts val="1200"/>
              </a:spcBef>
            </a:pPr>
            <a:r>
              <a:rPr lang="tr-TR" sz="1500" noProof="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500" noProof="0" dirty="0">
                <a:latin typeface="Arial" panose="020B0604020202020204" pitchFamily="34" charset="0"/>
                <a:cs typeface="Arial" panose="020B0604020202020204" pitchFamily="34" charset="0"/>
              </a:rPr>
              <a:t> patients without 22q11.2 deletion or not meeting </a:t>
            </a:r>
            <a:r>
              <a:rPr lang="tr-TR" sz="1500" noProof="0" dirty="0">
                <a:latin typeface="Arial" panose="020B0604020202020204" pitchFamily="34" charset="0"/>
                <a:cs typeface="Arial" panose="020B0604020202020204" pitchFamily="34" charset="0"/>
              </a:rPr>
              <a:t>DGS </a:t>
            </a:r>
            <a:r>
              <a:rPr lang="en-US" sz="1500" noProof="0" dirty="0">
                <a:latin typeface="Arial" panose="020B0604020202020204" pitchFamily="34" charset="0"/>
                <a:cs typeface="Arial" panose="020B0604020202020204" pitchFamily="34" charset="0"/>
              </a:rPr>
              <a:t>criteria</a:t>
            </a:r>
          </a:p>
        </p:txBody>
      </p:sp>
      <p:sp>
        <p:nvSpPr>
          <p:cNvPr id="10" name="Ok: Aşağı 9">
            <a:extLst>
              <a:ext uri="{FF2B5EF4-FFF2-40B4-BE49-F238E27FC236}">
                <a16:creationId xmlns:a16="http://schemas.microsoft.com/office/drawing/2014/main" id="{90ECDB6D-7B98-421B-17E5-6EE7F0B27B06}"/>
              </a:ext>
            </a:extLst>
          </p:cNvPr>
          <p:cNvSpPr/>
          <p:nvPr/>
        </p:nvSpPr>
        <p:spPr>
          <a:xfrm>
            <a:off x="5868853" y="2171557"/>
            <a:ext cx="145867" cy="127508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11" name="Ok: Aşağı 10">
            <a:extLst>
              <a:ext uri="{FF2B5EF4-FFF2-40B4-BE49-F238E27FC236}">
                <a16:creationId xmlns:a16="http://schemas.microsoft.com/office/drawing/2014/main" id="{CDCE7648-4B3E-96EA-E1D8-2BB3E247540C}"/>
              </a:ext>
            </a:extLst>
          </p:cNvPr>
          <p:cNvSpPr/>
          <p:nvPr/>
        </p:nvSpPr>
        <p:spPr>
          <a:xfrm>
            <a:off x="5893891" y="4107905"/>
            <a:ext cx="145867" cy="127508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13" name="Ok: Yukarı Bükülü 12">
            <a:extLst>
              <a:ext uri="{FF2B5EF4-FFF2-40B4-BE49-F238E27FC236}">
                <a16:creationId xmlns:a16="http://schemas.microsoft.com/office/drawing/2014/main" id="{37533206-A4B2-A979-CA09-0DB7FA760303}"/>
              </a:ext>
            </a:extLst>
          </p:cNvPr>
          <p:cNvSpPr/>
          <p:nvPr/>
        </p:nvSpPr>
        <p:spPr>
          <a:xfrm rot="10800000">
            <a:off x="3017519" y="2358461"/>
            <a:ext cx="2830287" cy="268822"/>
          </a:xfrm>
          <a:prstGeom prst="bentUpArrow">
            <a:avLst/>
          </a:prstGeom>
          <a:solidFill>
            <a:schemeClr val="bg1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k: Yukarı Bükülü 13">
            <a:extLst>
              <a:ext uri="{FF2B5EF4-FFF2-40B4-BE49-F238E27FC236}">
                <a16:creationId xmlns:a16="http://schemas.microsoft.com/office/drawing/2014/main" id="{BC436DC6-DA80-46AA-675F-FABADC8441ED}"/>
              </a:ext>
            </a:extLst>
          </p:cNvPr>
          <p:cNvSpPr/>
          <p:nvPr/>
        </p:nvSpPr>
        <p:spPr>
          <a:xfrm rot="10800000">
            <a:off x="3017519" y="4342212"/>
            <a:ext cx="2830287" cy="268822"/>
          </a:xfrm>
          <a:prstGeom prst="bentUpArrow">
            <a:avLst/>
          </a:prstGeom>
          <a:solidFill>
            <a:schemeClr val="bg1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76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2</Words>
  <Application>Microsoft Office PowerPoint</Application>
  <PresentationFormat>Geniş ekran</PresentationFormat>
  <Paragraphs>5</Paragraphs>
  <Slides>1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3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rve Süleyman</dc:creator>
  <cp:lastModifiedBy>Merve Süleyman</cp:lastModifiedBy>
  <cp:revision>1</cp:revision>
  <dcterms:created xsi:type="dcterms:W3CDTF">2025-02-21T14:37:05Z</dcterms:created>
  <dcterms:modified xsi:type="dcterms:W3CDTF">2025-02-21T14:52:19Z</dcterms:modified>
</cp:coreProperties>
</file>